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4972" autoAdjust="0"/>
    <p:restoredTop sz="94660"/>
  </p:normalViewPr>
  <p:slideViewPr>
    <p:cSldViewPr snapToGrid="0">
      <p:cViewPr varScale="1">
        <p:scale>
          <a:sx n="56" d="100"/>
          <a:sy n="56" d="100"/>
        </p:scale>
        <p:origin x="989" y="27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6202DB3-E444-D753-735D-3C3FE6BC9D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576A1B18-DEF9-58EF-0626-CD8E227CFF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618D644-C226-D176-D695-6F0A2064BD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528F5-D934-45FF-B56B-5EE149E5173A}" type="datetimeFigureOut">
              <a:rPr lang="fr-FR" smtClean="0"/>
              <a:pPr/>
              <a:t>04/05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A0A3694-8DEA-7F27-791E-F30CC4F73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641944F-5D3E-E849-C4B3-57495D42B7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3383-9916-40B8-B11F-AFAC3A9E30A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3813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108B89-6015-65D6-34D6-26AFBA5021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C412101-B825-D2F5-B1AB-0B5C663C97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7512A95-C3E4-DED5-8BAC-1238BFE57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528F5-D934-45FF-B56B-5EE149E5173A}" type="datetimeFigureOut">
              <a:rPr lang="fr-FR" smtClean="0"/>
              <a:pPr/>
              <a:t>04/05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4FA157F-2A28-7DE4-B18F-2F841CD7A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1C0C39D-6CC2-C1B6-960A-98802BFC4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3383-9916-40B8-B11F-AFAC3A9E30A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8411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604CB6B-1A90-FA2D-E529-1C7EBC5135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8BADBD0-616C-C2FD-C252-A3B6DB5953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CB9CA30-86F5-540B-BCBF-5CAE3BB6F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528F5-D934-45FF-B56B-5EE149E5173A}" type="datetimeFigureOut">
              <a:rPr lang="fr-FR" smtClean="0"/>
              <a:pPr/>
              <a:t>04/05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D548EC1-5800-0698-44DA-A010177F0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329D0E0-05D6-2C27-9A70-FED77EE1A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3383-9916-40B8-B11F-AFAC3A9E30A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3496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DCC85CC-BE89-0194-C3FF-74B5407A41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F725910-C640-A2D8-A3AF-3C7B75346C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A42EAE5-C1C6-FF37-AE11-A3CEAABC6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528F5-D934-45FF-B56B-5EE149E5173A}" type="datetimeFigureOut">
              <a:rPr lang="fr-FR" smtClean="0"/>
              <a:pPr/>
              <a:t>04/05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7C669AC-8F07-17FF-BDB5-E5E6BFA60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A8D873F-5D2D-A497-24F6-0CB55E511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3383-9916-40B8-B11F-AFAC3A9E30A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6226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75AEC7-6DAF-9A89-81E4-EFB9E93F5F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FEA1F85-3DC9-F785-685E-787370334C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69BBD07-FB72-719C-8A66-5CAE9B10F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528F5-D934-45FF-B56B-5EE149E5173A}" type="datetimeFigureOut">
              <a:rPr lang="fr-FR" smtClean="0"/>
              <a:pPr/>
              <a:t>04/05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1419FE9-587D-913C-EC31-9D09BB413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8807BDA-DCE7-4658-D410-76547D944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3383-9916-40B8-B11F-AFAC3A9E30A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7259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C18793F-FFBB-4A18-E8BE-8CCEEDE56D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B8C7EB2-2A9E-0CC6-953F-7477DA9FBD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5A8E397-7FB3-740F-5FDC-3E24FF0DFC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AA61584-1972-6084-AD9D-A46D7FDEF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528F5-D934-45FF-B56B-5EE149E5173A}" type="datetimeFigureOut">
              <a:rPr lang="fr-FR" smtClean="0"/>
              <a:pPr/>
              <a:t>04/05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E04051A-BD4D-00D3-D3E9-CF505F89F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8B6014B-4570-35D4-5883-4D09B7560B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3383-9916-40B8-B11F-AFAC3A9E30A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0745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9566E9-288E-5585-C1DE-CDEC6B0C39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960DD95-E25D-7ED9-F99B-EDC6E77532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11EDD58-792F-E8F6-0F0E-4E780ED373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F6C4C6FC-ADFC-C6D1-B067-A5E0C916D5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528B7C43-C885-0081-1EB4-35B6D07766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E8230AD3-DB38-3C4D-44C1-F83B9CFE8C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528F5-D934-45FF-B56B-5EE149E5173A}" type="datetimeFigureOut">
              <a:rPr lang="fr-FR" smtClean="0"/>
              <a:pPr/>
              <a:t>04/05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B5C6B38-4407-2E8B-E16F-16F2DE17A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A23B4996-5D90-14E9-8236-7C6BF706A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3383-9916-40B8-B11F-AFAC3A9E30A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3289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B603BEC-649E-57E0-A164-CD36EF58EC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33E9332-9DAF-86F5-58D9-E5B7C3A6C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528F5-D934-45FF-B56B-5EE149E5173A}" type="datetimeFigureOut">
              <a:rPr lang="fr-FR" smtClean="0"/>
              <a:pPr/>
              <a:t>04/05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94D9E9B-8A10-F94B-0A4F-278BA41E6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1FA6A68-7AA2-22AE-EB22-97AB84C31B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3383-9916-40B8-B11F-AFAC3A9E30A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8939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553767C-9196-3AC5-13C5-29AF5D2D9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528F5-D934-45FF-B56B-5EE149E5173A}" type="datetimeFigureOut">
              <a:rPr lang="fr-FR" smtClean="0"/>
              <a:pPr/>
              <a:t>04/05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07B1079-9014-85E3-2FC4-E8887EDA4C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B5B6B46F-3A12-6564-34B5-FDFF2B3A6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3383-9916-40B8-B11F-AFAC3A9E30A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0296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17B3E94-BE47-ADEC-C1CB-8468DB4F0B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1D2BE61-FB62-35C2-6089-9543CED89D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DBF8950-685F-93BB-FF46-302B74AC08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F04BBF0-3222-45E7-6E15-B26A5094BE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528F5-D934-45FF-B56B-5EE149E5173A}" type="datetimeFigureOut">
              <a:rPr lang="fr-FR" smtClean="0"/>
              <a:pPr/>
              <a:t>04/05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11551ED-332F-B56E-927D-DE22C3DEEF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F1EB003-C59E-554B-C6E1-529794FE6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3383-9916-40B8-B11F-AFAC3A9E30A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3182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C16A6F0-724E-5B40-E262-076EC28E01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B458230-C67F-3135-B1AA-0544DFFBD7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736ECD9-F95F-0C61-2354-0FCA4F8FF3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DD8CABE-3A33-4404-6F1F-34746E327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528F5-D934-45FF-B56B-5EE149E5173A}" type="datetimeFigureOut">
              <a:rPr lang="fr-FR" smtClean="0"/>
              <a:pPr/>
              <a:t>04/05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DF4E78B-129A-7987-3EFF-D43699524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1D3ACEA-D46D-32FD-2513-818772A252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3383-9916-40B8-B11F-AFAC3A9E30A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4476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7C9151CC-E06B-D6F6-4565-AB17D688A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91FDD29-DB86-A912-5C9A-4740DD144E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44F5363-FDC9-9CBD-22F6-0A27D6559A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6528F5-D934-45FF-B56B-5EE149E5173A}" type="datetimeFigureOut">
              <a:rPr lang="fr-FR" smtClean="0"/>
              <a:pPr/>
              <a:t>04/05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73258CB-E68D-F2BF-D18B-E890E97E9D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3001D59-5428-8D6B-15FF-E97D182522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CE13383-9916-40B8-B11F-AFAC3A9E30A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711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854EA795-4DBC-9EC8-A753-7B2A4B2AF789}"/>
              </a:ext>
            </a:extLst>
          </p:cNvPr>
          <p:cNvSpPr txBox="1"/>
          <p:nvPr/>
        </p:nvSpPr>
        <p:spPr>
          <a:xfrm>
            <a:off x="2344994" y="1784555"/>
            <a:ext cx="901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340 µm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4FDAC31B-56E5-DCC2-55A9-CCEBE2297FD7}"/>
              </a:ext>
            </a:extLst>
          </p:cNvPr>
          <p:cNvSpPr txBox="1"/>
          <p:nvPr/>
        </p:nvSpPr>
        <p:spPr>
          <a:xfrm>
            <a:off x="4557251" y="1777496"/>
            <a:ext cx="3348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380 µm                            300 µm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4F1D7EFC-E032-7FE1-A3DA-D1B2C762896F}"/>
              </a:ext>
            </a:extLst>
          </p:cNvPr>
          <p:cNvSpPr txBox="1"/>
          <p:nvPr/>
        </p:nvSpPr>
        <p:spPr>
          <a:xfrm>
            <a:off x="1856400" y="782123"/>
            <a:ext cx="206338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Absence of </a:t>
            </a:r>
            <a:r>
              <a:rPr lang="fr-FR" dirty="0" err="1">
                <a:latin typeface="Times New Roman" pitchFamily="18" charset="0"/>
                <a:cs typeface="Times New Roman" pitchFamily="18" charset="0"/>
              </a:rPr>
              <a:t>spine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,</a:t>
            </a:r>
          </a:p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at the end of simple </a:t>
            </a:r>
          </a:p>
          <a:p>
            <a:r>
              <a:rPr lang="fr-FR" dirty="0" err="1">
                <a:latin typeface="Times New Roman" pitchFamily="18" charset="0"/>
                <a:cs typeface="Times New Roman" pitchFamily="18" charset="0"/>
              </a:rPr>
              <a:t>curve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dirty="0" err="1">
                <a:latin typeface="Times New Roman" pitchFamily="18" charset="0"/>
                <a:cs typeface="Times New Roman" pitchFamily="18" charset="0"/>
              </a:rPr>
              <a:t>tail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FB4EBEC3-B6D3-639A-829F-366713911CFF}"/>
              </a:ext>
            </a:extLst>
          </p:cNvPr>
          <p:cNvSpPr txBox="1"/>
          <p:nvPr/>
        </p:nvSpPr>
        <p:spPr>
          <a:xfrm>
            <a:off x="4123609" y="782123"/>
            <a:ext cx="207620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Times New Roman" pitchFamily="18" charset="0"/>
                <a:cs typeface="Times New Roman" pitchFamily="18" charset="0"/>
              </a:rPr>
              <a:t>Presence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 of a </a:t>
            </a:r>
            <a:r>
              <a:rPr lang="fr-FR" dirty="0" err="1">
                <a:latin typeface="Times New Roman" pitchFamily="18" charset="0"/>
                <a:cs typeface="Times New Roman" pitchFamily="18" charset="0"/>
              </a:rPr>
              <a:t>spine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, </a:t>
            </a:r>
          </a:p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articulation of the </a:t>
            </a:r>
          </a:p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end of the </a:t>
            </a:r>
            <a:r>
              <a:rPr lang="fr-FR" dirty="0" err="1">
                <a:latin typeface="Times New Roman" pitchFamily="18" charset="0"/>
                <a:cs typeface="Times New Roman" pitchFamily="18" charset="0"/>
              </a:rPr>
              <a:t>tail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41B0E6C6-DD82-0214-6154-AF04B6E4D043}"/>
              </a:ext>
            </a:extLst>
          </p:cNvPr>
          <p:cNvSpPr txBox="1"/>
          <p:nvPr/>
        </p:nvSpPr>
        <p:spPr>
          <a:xfrm>
            <a:off x="6428585" y="752941"/>
            <a:ext cx="189026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Absence of </a:t>
            </a:r>
            <a:r>
              <a:rPr lang="fr-FR" dirty="0" err="1">
                <a:latin typeface="Times New Roman" pitchFamily="18" charset="0"/>
                <a:cs typeface="Times New Roman" pitchFamily="18" charset="0"/>
              </a:rPr>
              <a:t>spine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, </a:t>
            </a:r>
          </a:p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articulation of the </a:t>
            </a:r>
          </a:p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end of  the </a:t>
            </a:r>
            <a:r>
              <a:rPr lang="fr-FR" dirty="0" err="1">
                <a:latin typeface="Times New Roman" pitchFamily="18" charset="0"/>
                <a:cs typeface="Times New Roman" pitchFamily="18" charset="0"/>
              </a:rPr>
              <a:t>tail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FDACD4B1-A043-79D9-5B0C-6D4FDD274D32}"/>
              </a:ext>
            </a:extLst>
          </p:cNvPr>
          <p:cNvSpPr txBox="1"/>
          <p:nvPr/>
        </p:nvSpPr>
        <p:spPr>
          <a:xfrm>
            <a:off x="8889368" y="752941"/>
            <a:ext cx="233269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Times New Roman" pitchFamily="18" charset="0"/>
                <a:cs typeface="Times New Roman" pitchFamily="18" charset="0"/>
              </a:rPr>
              <a:t>Presence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 of a </a:t>
            </a:r>
            <a:r>
              <a:rPr lang="fr-FR" dirty="0" err="1">
                <a:latin typeface="Times New Roman" pitchFamily="18" charset="0"/>
                <a:cs typeface="Times New Roman" pitchFamily="18" charset="0"/>
              </a:rPr>
              <a:t>spine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, </a:t>
            </a:r>
          </a:p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absence of articulation,</a:t>
            </a:r>
          </a:p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double </a:t>
            </a:r>
            <a:r>
              <a:rPr lang="fr-FR" dirty="0" err="1">
                <a:latin typeface="Times New Roman" pitchFamily="18" charset="0"/>
                <a:cs typeface="Times New Roman" pitchFamily="18" charset="0"/>
              </a:rPr>
              <a:t>curves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dirty="0" err="1">
                <a:latin typeface="Times New Roman" pitchFamily="18" charset="0"/>
                <a:cs typeface="Times New Roman" pitchFamily="18" charset="0"/>
              </a:rPr>
              <a:t>tail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104EB942-A48C-7699-48C6-5C9A6BE17569}"/>
              </a:ext>
            </a:extLst>
          </p:cNvPr>
          <p:cNvSpPr txBox="1"/>
          <p:nvPr/>
        </p:nvSpPr>
        <p:spPr>
          <a:xfrm>
            <a:off x="9492164" y="1768181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275 µm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116D4E1-C81D-955E-75C6-06AC96D67576}"/>
              </a:ext>
            </a:extLst>
          </p:cNvPr>
          <p:cNvSpPr txBox="1"/>
          <p:nvPr/>
        </p:nvSpPr>
        <p:spPr>
          <a:xfrm>
            <a:off x="590944" y="258753"/>
            <a:ext cx="11018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Times New Roman" pitchFamily="18" charset="0"/>
                <a:cs typeface="Times New Roman" pitchFamily="18" charset="0"/>
              </a:rPr>
              <a:t>Supplementary Figure 1: Identification of protostronglid  larvae (tail morphology and  total length)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840710" y="2229423"/>
            <a:ext cx="9572625" cy="3857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F6214B6B-4DD7-3B28-E2F0-6CF66ABB131A}"/>
              </a:ext>
            </a:extLst>
          </p:cNvPr>
          <p:cNvSpPr txBox="1"/>
          <p:nvPr/>
        </p:nvSpPr>
        <p:spPr>
          <a:xfrm>
            <a:off x="1797346" y="6201015"/>
            <a:ext cx="9322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/>
              <a:t>           </a:t>
            </a:r>
            <a:r>
              <a:rPr lang="fr-FR" i="1" dirty="0" err="1"/>
              <a:t>Protostrongylus</a:t>
            </a:r>
            <a:r>
              <a:rPr lang="fr-FR" i="1" dirty="0"/>
              <a:t>                              </a:t>
            </a:r>
            <a:r>
              <a:rPr lang="fr-FR" i="1" dirty="0" err="1"/>
              <a:t>Cystocaulus</a:t>
            </a:r>
            <a:r>
              <a:rPr lang="fr-FR" i="1" dirty="0"/>
              <a:t>                 </a:t>
            </a:r>
            <a:r>
              <a:rPr lang="fr-FR" i="1" dirty="0" err="1"/>
              <a:t>Neostrongylus</a:t>
            </a:r>
            <a:r>
              <a:rPr lang="fr-FR" i="1" dirty="0"/>
              <a:t>                    </a:t>
            </a:r>
            <a:r>
              <a:rPr lang="fr-FR" i="1" dirty="0" err="1"/>
              <a:t>Muellerius</a:t>
            </a:r>
            <a:r>
              <a:rPr lang="fr-FR" i="1" dirty="0"/>
              <a:t>      </a:t>
            </a:r>
          </a:p>
        </p:txBody>
      </p:sp>
    </p:spTree>
    <p:extLst>
      <p:ext uri="{BB962C8B-B14F-4D97-AF65-F5344CB8AC3E}">
        <p14:creationId xmlns:p14="http://schemas.microsoft.com/office/powerpoint/2010/main" val="185320123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78</Words>
  <Application>Microsoft Office PowerPoint</Application>
  <PresentationFormat>Grand écran</PresentationFormat>
  <Paragraphs>1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Jacques Cabaret</dc:creator>
  <cp:lastModifiedBy>Jacques Cabaret</cp:lastModifiedBy>
  <cp:revision>6</cp:revision>
  <dcterms:created xsi:type="dcterms:W3CDTF">2025-04-30T11:11:10Z</dcterms:created>
  <dcterms:modified xsi:type="dcterms:W3CDTF">2025-05-04T11:48:35Z</dcterms:modified>
</cp:coreProperties>
</file>